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1458" y="3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23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1377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052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141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7173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840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0966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5833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640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5412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1814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42C6C-DA93-4EBD-8FBB-1AAD33D23607}" type="datetimeFigureOut">
              <a:rPr kumimoji="1" lang="ja-JP" altLang="en-US" smtClean="0"/>
              <a:t>2015/8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1E3B72-96C9-4C11-8A07-397EF09F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8348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5868000" y="1368000"/>
            <a:ext cx="3168000" cy="1224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xclusion (</a:t>
            </a:r>
            <a:r>
              <a:rPr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31)</a:t>
            </a:r>
          </a:p>
          <a:p>
            <a:r>
              <a:rPr kumimoji="1" lang="en-US" altLang="ja-JP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dementia with Lewy bodies (</a:t>
            </a:r>
            <a:r>
              <a:rPr kumimoji="1"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20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3)</a:t>
            </a:r>
            <a:endParaRPr kumimoji="1" lang="en-US" altLang="ja-JP" sz="1200" dirty="0" smtClean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r>
              <a:rPr lang="en-US" altLang="ja-JP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st DBS surgery (</a:t>
            </a:r>
            <a:r>
              <a:rPr kumimoji="1"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10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)</a:t>
            </a:r>
          </a:p>
          <a:p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cancer (</a:t>
            </a:r>
            <a:r>
              <a:rPr kumimoji="1"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9)</a:t>
            </a:r>
          </a:p>
          <a:p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autoimmune disease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6)</a:t>
            </a:r>
          </a:p>
          <a:p>
            <a:r>
              <a:rPr lang="en-US" altLang="ja-JP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previous infection within one month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</a:t>
            </a:r>
            <a:r>
              <a:rPr kumimoji="1"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3)</a:t>
            </a:r>
          </a:p>
        </p:txBody>
      </p:sp>
      <p:sp>
        <p:nvSpPr>
          <p:cNvPr id="3" name="正方形/長方形 2"/>
          <p:cNvSpPr/>
          <p:nvPr/>
        </p:nvSpPr>
        <p:spPr>
          <a:xfrm>
            <a:off x="1800000" y="540000"/>
            <a:ext cx="3672000" cy="36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tients with PD (modified H-Y </a:t>
            </a:r>
            <a:r>
              <a:rPr lang="en-US" altLang="ja-JP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tage ≤ 4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) (</a:t>
            </a:r>
            <a:r>
              <a:rPr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406)</a:t>
            </a:r>
            <a:endParaRPr kumimoji="1" lang="ja-JP" alt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" name="図形 47"/>
          <p:cNvCxnSpPr>
            <a:stCxn id="3" idx="2"/>
            <a:endCxn id="2" idx="1"/>
          </p:cNvCxnSpPr>
          <p:nvPr/>
        </p:nvCxnSpPr>
        <p:spPr>
          <a:xfrm rot="16200000" flipH="1">
            <a:off x="4212000" y="324000"/>
            <a:ext cx="1080000" cy="2232000"/>
          </a:xfrm>
          <a:prstGeom prst="bentConnector2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矢印コネクタ 4"/>
          <p:cNvCxnSpPr>
            <a:stCxn id="3" idx="2"/>
            <a:endCxn id="15" idx="0"/>
          </p:cNvCxnSpPr>
          <p:nvPr/>
        </p:nvCxnSpPr>
        <p:spPr>
          <a:xfrm>
            <a:off x="3636000" y="900000"/>
            <a:ext cx="0" cy="21600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108000" y="72000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itchFamily="34" charset="0"/>
                <a:cs typeface="Arial" pitchFamily="34" charset="0"/>
              </a:rPr>
              <a:t>S2 Figure</a:t>
            </a:r>
            <a:endParaRPr kumimoji="1" lang="ja-JP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80000" y="5940000"/>
            <a:ext cx="2880000" cy="72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nalysis I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</a:t>
            </a:r>
            <a:r>
              <a:rPr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375)</a:t>
            </a:r>
          </a:p>
          <a:p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for the entire follow-up period in a generalized estimation equation model</a:t>
            </a:r>
            <a:endParaRPr kumimoji="1" lang="ja-JP" alt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4140000" y="5940000"/>
            <a:ext cx="2880000" cy="72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nalysis II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</a:t>
            </a:r>
            <a:r>
              <a:rPr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200)</a:t>
            </a:r>
          </a:p>
          <a:p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for the final period </a:t>
            </a:r>
            <a:r>
              <a:rPr lang="en-US" altLang="ja-JP" sz="120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f Days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631–900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n a generalized linear model</a:t>
            </a:r>
            <a:endParaRPr kumimoji="1" lang="ja-JP" alt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7236000" y="4860000"/>
            <a:ext cx="1800000" cy="54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xcluded for Analysis II</a:t>
            </a:r>
          </a:p>
          <a:p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censored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kumimoji="1"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</a:t>
            </a:r>
            <a:r>
              <a:rPr kumimoji="1"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= 175)</a:t>
            </a:r>
          </a:p>
        </p:txBody>
      </p:sp>
      <p:cxnSp>
        <p:nvCxnSpPr>
          <p:cNvPr id="13" name="図形 47"/>
          <p:cNvCxnSpPr>
            <a:stCxn id="9" idx="0"/>
            <a:endCxn id="12" idx="1"/>
          </p:cNvCxnSpPr>
          <p:nvPr/>
        </p:nvCxnSpPr>
        <p:spPr>
          <a:xfrm rot="5400000" flipH="1" flipV="1">
            <a:off x="6003000" y="4707000"/>
            <a:ext cx="810000" cy="1656000"/>
          </a:xfrm>
          <a:prstGeom prst="bentConnector2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正方形/長方形 14"/>
          <p:cNvSpPr/>
          <p:nvPr/>
        </p:nvSpPr>
        <p:spPr>
          <a:xfrm>
            <a:off x="1800000" y="3060000"/>
            <a:ext cx="3672000" cy="36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tients with PD (modified H-Y </a:t>
            </a:r>
            <a:r>
              <a:rPr lang="en-US" altLang="ja-JP" sz="12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tage ≤ 4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) (</a:t>
            </a:r>
            <a:r>
              <a:rPr lang="en-US" altLang="ja-JP" sz="1200" i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n </a:t>
            </a:r>
            <a:r>
              <a:rPr lang="en-US" altLang="ja-JP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= 375)</a:t>
            </a:r>
            <a:endParaRPr kumimoji="1" lang="ja-JP" alt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図形 47"/>
          <p:cNvCxnSpPr>
            <a:stCxn id="15" idx="2"/>
            <a:endCxn id="7" idx="0"/>
          </p:cNvCxnSpPr>
          <p:nvPr/>
        </p:nvCxnSpPr>
        <p:spPr>
          <a:xfrm rot="5400000">
            <a:off x="1368000" y="3672000"/>
            <a:ext cx="2520000" cy="20160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図形 47"/>
          <p:cNvCxnSpPr>
            <a:stCxn id="15" idx="2"/>
            <a:endCxn id="9" idx="0"/>
          </p:cNvCxnSpPr>
          <p:nvPr/>
        </p:nvCxnSpPr>
        <p:spPr>
          <a:xfrm rot="16200000" flipH="1">
            <a:off x="3348000" y="3708000"/>
            <a:ext cx="2520000" cy="1944000"/>
          </a:xfrm>
          <a:prstGeom prst="bentConnector3">
            <a:avLst>
              <a:gd name="adj1" fmla="val 50000"/>
            </a:avLst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7927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131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tsushi</dc:creator>
  <cp:lastModifiedBy>Hideyuki Sawada</cp:lastModifiedBy>
  <cp:revision>10</cp:revision>
  <dcterms:created xsi:type="dcterms:W3CDTF">2014-12-13T09:15:28Z</dcterms:created>
  <dcterms:modified xsi:type="dcterms:W3CDTF">2015-08-07T07:32:10Z</dcterms:modified>
</cp:coreProperties>
</file>